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625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771" autoAdjust="0"/>
    <p:restoredTop sz="94660"/>
  </p:normalViewPr>
  <p:slideViewPr>
    <p:cSldViewPr snapToGrid="0">
      <p:cViewPr varScale="1">
        <p:scale>
          <a:sx n="50" d="100"/>
          <a:sy n="50" d="100"/>
        </p:scale>
        <p:origin x="324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CADF-AB18-4B82-875A-D529DF14B6CD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3968-7318-429F-B71D-50D7A22E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1488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CADF-AB18-4B82-875A-D529DF14B6CD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3968-7318-429F-B71D-50D7A22E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470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CADF-AB18-4B82-875A-D529DF14B6CD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3968-7318-429F-B71D-50D7A22E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049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CADF-AB18-4B82-875A-D529DF14B6CD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3968-7318-429F-B71D-50D7A22E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867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CADF-AB18-4B82-875A-D529DF14B6CD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3968-7318-429F-B71D-50D7A22E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479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CADF-AB18-4B82-875A-D529DF14B6CD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3968-7318-429F-B71D-50D7A22E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552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CADF-AB18-4B82-875A-D529DF14B6CD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3968-7318-429F-B71D-50D7A22E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0868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CADF-AB18-4B82-875A-D529DF14B6CD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3968-7318-429F-B71D-50D7A22E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7465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CADF-AB18-4B82-875A-D529DF14B6CD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3968-7318-429F-B71D-50D7A22E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770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CADF-AB18-4B82-875A-D529DF14B6CD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3968-7318-429F-B71D-50D7A22E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256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CADF-AB18-4B82-875A-D529DF14B6CD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3968-7318-429F-B71D-50D7A22E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320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16CADF-AB18-4B82-875A-D529DF14B6CD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CF3968-7318-429F-B71D-50D7A22E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4250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066866" y="14159172"/>
            <a:ext cx="977392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altLang="zh-CN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ig</a:t>
            </a:r>
            <a:r>
              <a:rPr lang="en-US" altLang="zh-CN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3 </a:t>
            </a:r>
            <a:r>
              <a:rPr lang="en-US" altLang="zh-CN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Relationship of the </a:t>
            </a:r>
            <a:r>
              <a:rPr lang="en-US" altLang="zh-CN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RLK</a:t>
            </a:r>
            <a:r>
              <a:rPr lang="en-US" altLang="zh-CN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gene </a:t>
            </a:r>
            <a:r>
              <a:rPr lang="en-US" altLang="zh-CN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hylogeny </a:t>
            </a:r>
            <a:r>
              <a:rPr lang="en-US" altLang="zh-CN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with their expression activities. Thirty-three of the </a:t>
            </a:r>
            <a:r>
              <a:rPr lang="en-US" altLang="zh-CN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RLK</a:t>
            </a:r>
            <a:r>
              <a:rPr lang="en-US" altLang="zh-CN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genes belonging to three of the eight types of the </a:t>
            </a:r>
            <a:r>
              <a:rPr lang="en-US" altLang="zh-CN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RLK</a:t>
            </a:r>
            <a:r>
              <a:rPr lang="en-US" altLang="zh-CN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gene family were analyzed for this study. </a:t>
            </a:r>
            <a:r>
              <a:rPr lang="en-US" altLang="zh-CN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zh-CN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he phylogenetic tree of the 33 </a:t>
            </a:r>
            <a:r>
              <a:rPr lang="en-US" altLang="zh-CN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RLK</a:t>
            </a:r>
            <a:r>
              <a:rPr lang="en-US" altLang="zh-CN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genes. Different colors show different types of the </a:t>
            </a:r>
            <a:r>
              <a:rPr lang="en-US" altLang="zh-CN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RLK</a:t>
            </a:r>
            <a:r>
              <a:rPr lang="en-US" altLang="zh-CN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gene family. </a:t>
            </a:r>
            <a:r>
              <a:rPr lang="en-US" altLang="zh-CN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zh-CN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zh-CN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heatmap</a:t>
            </a:r>
            <a:r>
              <a:rPr lang="en-US" altLang="zh-CN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of the 33 </a:t>
            </a:r>
            <a:r>
              <a:rPr lang="en-US" altLang="zh-CN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RLK</a:t>
            </a:r>
            <a:r>
              <a:rPr lang="en-US" altLang="zh-CN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genes in 14 tissues. </a:t>
            </a:r>
            <a:r>
              <a:rPr lang="en-US" altLang="zh-CN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 </a:t>
            </a:r>
            <a:r>
              <a:rPr lang="en-US" altLang="zh-CN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zh-CN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heatmap</a:t>
            </a:r>
            <a:r>
              <a:rPr lang="en-US" altLang="zh-CN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of the 33 </a:t>
            </a:r>
            <a:r>
              <a:rPr lang="en-US" altLang="zh-CN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RLK</a:t>
            </a:r>
            <a:r>
              <a:rPr lang="en-US" altLang="zh-CN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genes in 42 cultivars</a:t>
            </a:r>
            <a:r>
              <a:rPr lang="en-US" altLang="zh-CN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.</a:t>
            </a:r>
            <a:endParaRPr lang="en-US" altLang="zh-CN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 descr="C:\Users\Administrator\Desktop\7组cluster-原始数据\heatmap\heatmap-42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6722" y="6692117"/>
            <a:ext cx="9879918" cy="7411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2" descr="C:\Users\Administrator\Desktop\7组cluster-原始数据\进化树\7组进化树（33）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00" r="46400"/>
          <a:stretch/>
        </p:blipFill>
        <p:spPr bwMode="auto">
          <a:xfrm>
            <a:off x="1178560" y="781079"/>
            <a:ext cx="3368817" cy="63174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3" descr="C:\Users\Administrator\Desktop\7组cluster-原始数据\heatmap\heatmap-14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7806" y="781079"/>
            <a:ext cx="5429813" cy="58055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5201920" y="84258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217642" y="781079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581844" y="7031514"/>
            <a:ext cx="2648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49224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85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AMU Soil &amp; Crop Sciences Dept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ngbin Zhang</dc:creator>
  <cp:lastModifiedBy>Meiping Zhang</cp:lastModifiedBy>
  <cp:revision>7</cp:revision>
  <dcterms:created xsi:type="dcterms:W3CDTF">2017-05-21T15:14:23Z</dcterms:created>
  <dcterms:modified xsi:type="dcterms:W3CDTF">2017-12-27T21:46:48Z</dcterms:modified>
</cp:coreProperties>
</file>